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94" r:id="rId2"/>
    <p:sldId id="306" r:id="rId3"/>
    <p:sldId id="295" r:id="rId4"/>
    <p:sldId id="298" r:id="rId5"/>
    <p:sldId id="302" r:id="rId6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Beyer, Jörg" initials="BJ" lastIdx="2" clrIdx="0">
    <p:extLst>
      <p:ext uri="{19B8F6BF-5375-455C-9EA6-DF929625EA0E}">
        <p15:presenceInfo xmlns:p15="http://schemas.microsoft.com/office/powerpoint/2012/main" userId="Beyer, Jörg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83" autoAdjust="0"/>
    <p:restoredTop sz="94654"/>
  </p:normalViewPr>
  <p:slideViewPr>
    <p:cSldViewPr snapToGrid="0">
      <p:cViewPr varScale="1">
        <p:scale>
          <a:sx n="104" d="100"/>
          <a:sy n="104" d="100"/>
        </p:scale>
        <p:origin x="936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H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B6B5E8C-0D6B-9549-B914-292E9FEF06CF}" type="datetimeFigureOut">
              <a:rPr lang="en-CH" smtClean="0"/>
              <a:t>07.09.23</a:t>
            </a:fld>
            <a:endParaRPr lang="en-CH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H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EEA318D-CEFA-2A4A-A81D-4151F6E00933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19395962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CH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1D946E7-0A4C-804F-A932-5426913AC9E3}" type="slidenum">
              <a:rPr lang="en-CH" smtClean="0"/>
              <a:t>2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97473090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05BADDE-E78F-4AD1-B5A9-396231E2229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29711FB7-277B-4656-8A8C-249841DA6C8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  <a:endParaRPr lang="de-CH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128ED2E4-4F3D-4041-A668-B5A37A690E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64E1AF-96F2-4E21-8E2C-EFE94E668756}" type="datetimeFigureOut">
              <a:rPr lang="de-CH" smtClean="0"/>
              <a:t>07.09.23</a:t>
            </a:fld>
            <a:endParaRPr lang="de-CH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633BCB36-5349-43E4-8F55-6872AEA4A6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98354014-6CCF-4237-A5E7-642DBDACF0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7D7B4-2647-4482-8872-1C6DB03F78A4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0989261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691CADE-95A7-4CBD-9E9D-BBA39489D1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114EE2FF-444E-435D-AC9E-AC6C5591AB1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FB6193B3-E7C9-479B-B5D6-1419C19095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64E1AF-96F2-4E21-8E2C-EFE94E668756}" type="datetimeFigureOut">
              <a:rPr lang="de-CH" smtClean="0"/>
              <a:t>07.09.23</a:t>
            </a:fld>
            <a:endParaRPr lang="de-CH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030B1B9E-CBB0-49A8-96B0-290BC1EED9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721700DE-3B9B-4973-B52B-2E74665AEB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7D7B4-2647-4482-8872-1C6DB03F78A4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8208539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AC5C0665-0354-434D-9186-9138FDF68D1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4EBC7D71-C028-4D5A-A68D-92C910C9565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CD69C851-C149-4167-9598-2B46E62B62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64E1AF-96F2-4E21-8E2C-EFE94E668756}" type="datetimeFigureOut">
              <a:rPr lang="de-CH" smtClean="0"/>
              <a:t>07.09.23</a:t>
            </a:fld>
            <a:endParaRPr lang="de-CH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C628E44B-4876-489D-8227-76FFBF616B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D4300DCD-12F4-4370-BFF5-7B1D74B46D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7D7B4-2647-4482-8872-1C6DB03F78A4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2993693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C528D25-B8C7-4217-B70B-DD3E002BED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DDC329C0-7BD7-4C0E-AD61-06FE370E4D9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89FD1E87-F18E-4184-BE5D-55AF300454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64E1AF-96F2-4E21-8E2C-EFE94E668756}" type="datetimeFigureOut">
              <a:rPr lang="de-CH" smtClean="0"/>
              <a:t>07.09.23</a:t>
            </a:fld>
            <a:endParaRPr lang="de-CH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B912DB82-D3D3-4764-9D4C-D4061A83DA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DCD96EDC-4E5A-412A-B51A-B4DDC4097A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7D7B4-2647-4482-8872-1C6DB03F78A4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2019201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08B1F1B-AB2D-4E24-853C-8201E80876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FB44E201-F56B-4093-A794-0412F15B67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191ADC6-0C32-4382-A484-1B98E45AA7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64E1AF-96F2-4E21-8E2C-EFE94E668756}" type="datetimeFigureOut">
              <a:rPr lang="de-CH" smtClean="0"/>
              <a:t>07.09.23</a:t>
            </a:fld>
            <a:endParaRPr lang="de-CH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02854883-8118-4B95-9E17-E234DE4E7D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15E318D4-FE8B-44D8-B070-D2B4B1E589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7D7B4-2647-4482-8872-1C6DB03F78A4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8555176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CB4DFAB-4701-4399-964C-D91C269894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51CF09C7-5952-40CE-993D-981EEEF0837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D978B068-56EB-4EE8-88D6-4E3B57185DD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C6211711-E9FB-4D0B-B2B4-31CCB99986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64E1AF-96F2-4E21-8E2C-EFE94E668756}" type="datetimeFigureOut">
              <a:rPr lang="de-CH" smtClean="0"/>
              <a:t>07.09.23</a:t>
            </a:fld>
            <a:endParaRPr lang="de-CH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18976FB2-ABDC-4917-98AB-03D6AB2CFD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64F0BBC6-F6AC-4F7C-AC34-073BCC95BF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7D7B4-2647-4482-8872-1C6DB03F78A4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5976359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D92631D-B1D8-4E45-9413-8F26BAD6CC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C23A361F-DB00-4AE0-AFE5-531F564C28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774CA762-8FB9-4FDE-BA1F-D9B5FDE6495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4B4270B5-B843-4257-8EB7-5B44DCE1A68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CFE9E608-98F3-4415-B722-FDD4CF8A7A4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B8199566-F308-4500-84D1-01193BD104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64E1AF-96F2-4E21-8E2C-EFE94E668756}" type="datetimeFigureOut">
              <a:rPr lang="de-CH" smtClean="0"/>
              <a:t>07.09.23</a:t>
            </a:fld>
            <a:endParaRPr lang="de-CH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EDBB5661-F725-4671-BA5C-FCE9F4911B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BE7D9CE9-BBE4-45ED-8ADC-74F4E12E6C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7D7B4-2647-4482-8872-1C6DB03F78A4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4776708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1AEA374-9424-4F1A-A078-BDD4374635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7BE92B97-6E71-478F-B76C-0B61DBE19E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64E1AF-96F2-4E21-8E2C-EFE94E668756}" type="datetimeFigureOut">
              <a:rPr lang="de-CH" smtClean="0"/>
              <a:t>07.09.23</a:t>
            </a:fld>
            <a:endParaRPr lang="de-CH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05C08A50-F839-48B5-A2A7-4068030975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7D956BD1-6EEF-4BD8-A293-C86052E867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7D7B4-2647-4482-8872-1C6DB03F78A4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9384731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50F66369-2276-4702-ABB8-ABB0638D3C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64E1AF-96F2-4E21-8E2C-EFE94E668756}" type="datetimeFigureOut">
              <a:rPr lang="de-CH" smtClean="0"/>
              <a:t>07.09.23</a:t>
            </a:fld>
            <a:endParaRPr lang="de-CH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4DB4320A-B82C-4D0E-8C7A-CFAF37E0BF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8A2E3AE0-9833-4180-BD67-D6F69214C4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7D7B4-2647-4482-8872-1C6DB03F78A4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9718826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6D1940D-6E23-413F-8064-A1CD9B0FB8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0CE30BAF-D51E-452B-A67E-4177EB7CDF4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0D27970D-BFE5-478B-A037-F752354581A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62BD2DB4-06BF-4C48-A828-A4516D08C6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64E1AF-96F2-4E21-8E2C-EFE94E668756}" type="datetimeFigureOut">
              <a:rPr lang="de-CH" smtClean="0"/>
              <a:t>07.09.23</a:t>
            </a:fld>
            <a:endParaRPr lang="de-CH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98F14D39-96BC-4152-BAF8-3A2DE2A760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B3D7EB6B-BD6D-4FD2-8E1B-0EED2025F8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7D7B4-2647-4482-8872-1C6DB03F78A4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6254560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CD1FE52-E97D-4DC3-A155-9FC20B54DA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42F7B83A-E563-4518-9CD4-B74506506F3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CH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17B39E66-1640-4CD1-9ABA-238448E337B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CCEDC501-21FD-4EEE-A108-E44156FCAA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64E1AF-96F2-4E21-8E2C-EFE94E668756}" type="datetimeFigureOut">
              <a:rPr lang="de-CH" smtClean="0"/>
              <a:t>07.09.23</a:t>
            </a:fld>
            <a:endParaRPr lang="de-CH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43ED0288-6AB3-498D-B92C-A1A3424924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660FCD33-0A04-414D-9374-3DB93064D0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7D7B4-2647-4482-8872-1C6DB03F78A4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1985158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7780AEF5-71E6-432E-955C-2B05250C49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de-CH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EDE5800B-6BD2-4618-A5BE-F6DD39EA093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3B4CB01-6D14-4B5D-9ED4-7E839A4935F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64E1AF-96F2-4E21-8E2C-EFE94E668756}" type="datetimeFigureOut">
              <a:rPr lang="de-CH" smtClean="0"/>
              <a:t>07.09.23</a:t>
            </a:fld>
            <a:endParaRPr lang="de-CH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00FE953C-777F-4796-AD70-A1C1677FF69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CH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0226758C-CA5D-45EE-BB6B-45B5B033DEB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67D7B4-2647-4482-8872-1C6DB03F78A4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712533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ti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"/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7.tif"/><Relationship Id="rId4" Type="http://schemas.openxmlformats.org/officeDocument/2006/relationships/image" Target="../media/image6.ti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"/><Relationship Id="rId2" Type="http://schemas.openxmlformats.org/officeDocument/2006/relationships/image" Target="../media/image8.ti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0.ti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tif"/><Relationship Id="rId2" Type="http://schemas.openxmlformats.org/officeDocument/2006/relationships/image" Target="../media/image11.ti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TextBox 34">
            <a:extLst>
              <a:ext uri="{FF2B5EF4-FFF2-40B4-BE49-F238E27FC236}">
                <a16:creationId xmlns:a16="http://schemas.microsoft.com/office/drawing/2014/main" id="{ED25DC12-5E9C-B7F2-4D4A-FD660AF0EA3E}"/>
              </a:ext>
            </a:extLst>
          </p:cNvPr>
          <p:cNvSpPr txBox="1"/>
          <p:nvPr/>
        </p:nvSpPr>
        <p:spPr>
          <a:xfrm>
            <a:off x="10646734" y="6400989"/>
            <a:ext cx="14766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1400" b="1">
                <a:latin typeface="Arial" panose="020B0604020202020204" pitchFamily="34" charset="0"/>
                <a:cs typeface="Arial" panose="020B0604020202020204" pitchFamily="34" charset="0"/>
              </a:rPr>
              <a:t>Suppl. Figure 1</a:t>
            </a:r>
            <a:endParaRPr lang="en-CH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FF0A175-D5E8-7C2B-BD9C-3CC36B025ABC}"/>
              </a:ext>
            </a:extLst>
          </p:cNvPr>
          <p:cNvSpPr txBox="1"/>
          <p:nvPr/>
        </p:nvSpPr>
        <p:spPr>
          <a:xfrm>
            <a:off x="729049" y="5351546"/>
            <a:ext cx="10960443" cy="116608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. Figure 1:</a:t>
            </a:r>
            <a:r>
              <a:rPr lang="en-US" sz="12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chematic diagram illustrating descriptive analysis for clinical stage I patients. </a:t>
            </a:r>
            <a:r>
              <a:rPr lang="en-US" sz="12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bbreviations: AS: active surveillance; </a:t>
            </a:r>
            <a:r>
              <a:rPr lang="en-US" sz="1200" dirty="0" err="1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hT</a:t>
            </a:r>
            <a:r>
              <a:rPr lang="en-US" sz="12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 chemotherapy; IGCCCG: International Germ Cell Cancer Cooperative Group; RPLND: Retroperitoneal lymph node dissection; RT: radiotherapy. </a:t>
            </a:r>
            <a:r>
              <a:rPr lang="en-US" sz="1200" baseline="300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</a:t>
            </a:r>
            <a:r>
              <a:rPr lang="en-US" sz="12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Including teratoma (n = 4), excluding unknown/burned-out histology (n = 1); </a:t>
            </a:r>
            <a:r>
              <a:rPr lang="en-US" sz="1200" baseline="300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 </a:t>
            </a:r>
            <a:r>
              <a:rPr lang="en-US" sz="1200" dirty="0" err="1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hT</a:t>
            </a:r>
            <a:r>
              <a:rPr lang="en-US" sz="12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Sem: Carboplatin (n = 71), BEP (n = 1), other; oncovin, dactinomycin, cyclophosphamide (n = 1). </a:t>
            </a:r>
            <a:r>
              <a:rPr lang="en-US" sz="1200" dirty="0" err="1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hT</a:t>
            </a:r>
            <a:r>
              <a:rPr lang="en-US" sz="12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200" dirty="0" err="1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sem</a:t>
            </a:r>
            <a:r>
              <a:rPr lang="en-US" sz="12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 BEP (n = 29), Carboplatin (n = 6).</a:t>
            </a:r>
            <a:endParaRPr lang="en-CH" sz="12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pic>
        <p:nvPicPr>
          <p:cNvPr id="7" name="Picture 6" descr="A black background with a square&#10;&#10;Description automatically generated">
            <a:extLst>
              <a:ext uri="{FF2B5EF4-FFF2-40B4-BE49-F238E27FC236}">
                <a16:creationId xmlns:a16="http://schemas.microsoft.com/office/drawing/2014/main" id="{DECAF955-AB68-B300-9C21-6DD4DC96098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92917" y="290938"/>
            <a:ext cx="9432706" cy="496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833245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D6B3716B-CB7C-8C79-5A3F-8F37A6B01C9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3816" y="341957"/>
            <a:ext cx="5540267" cy="4032000"/>
          </a:xfrm>
          <a:prstGeom prst="rect">
            <a:avLst/>
          </a:prstGeom>
        </p:spPr>
      </p:pic>
      <p:pic>
        <p:nvPicPr>
          <p:cNvPr id="10" name="Picture 9" descr="Graphical user interface, chart&#10;&#10;Description automatically generated">
            <a:extLst>
              <a:ext uri="{FF2B5EF4-FFF2-40B4-BE49-F238E27FC236}">
                <a16:creationId xmlns:a16="http://schemas.microsoft.com/office/drawing/2014/main" id="{BB8CAE75-BE49-A4ED-8DF5-195C1B2CB61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14697" y="341957"/>
            <a:ext cx="5540267" cy="40320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B47CDA75-7B78-6392-1D52-481D07D9A946}"/>
              </a:ext>
            </a:extLst>
          </p:cNvPr>
          <p:cNvSpPr txBox="1"/>
          <p:nvPr/>
        </p:nvSpPr>
        <p:spPr>
          <a:xfrm>
            <a:off x="65084" y="437734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EA90BFF-BB15-C215-2F33-244E9D98A21B}"/>
              </a:ext>
            </a:extLst>
          </p:cNvPr>
          <p:cNvSpPr txBox="1"/>
          <p:nvPr/>
        </p:nvSpPr>
        <p:spPr>
          <a:xfrm>
            <a:off x="5901879" y="437734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C1AA226-A72B-58DB-9776-E9421B0B670F}"/>
              </a:ext>
            </a:extLst>
          </p:cNvPr>
          <p:cNvSpPr txBox="1"/>
          <p:nvPr/>
        </p:nvSpPr>
        <p:spPr>
          <a:xfrm>
            <a:off x="3098170" y="2479664"/>
            <a:ext cx="288684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5-yr OS: 9</a:t>
            </a:r>
            <a:r>
              <a:rPr lang="en-US" sz="1400" dirty="0">
                <a:latin typeface="Arial" panose="020B0604020202020204" pitchFamily="34" charset="0"/>
                <a:ea typeface="Times New Roman" panose="02020603050405020304" pitchFamily="18" charset="0"/>
              </a:rPr>
              <a:t>4</a:t>
            </a: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% vs </a:t>
            </a:r>
            <a:r>
              <a:rPr lang="en-US" sz="1400" dirty="0">
                <a:latin typeface="Arial" panose="020B0604020202020204" pitchFamily="34" charset="0"/>
                <a:ea typeface="Times New Roman" panose="02020603050405020304" pitchFamily="18" charset="0"/>
              </a:rPr>
              <a:t>85</a:t>
            </a:r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% (p =0.044)</a:t>
            </a:r>
            <a:endParaRPr lang="en-CH" sz="14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60FBED8-FFAB-F10F-5203-3F6C17F3B8DD}"/>
              </a:ext>
            </a:extLst>
          </p:cNvPr>
          <p:cNvSpPr txBox="1"/>
          <p:nvPr/>
        </p:nvSpPr>
        <p:spPr>
          <a:xfrm>
            <a:off x="8994800" y="2479664"/>
            <a:ext cx="288684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5-yr PFS: 86% vs 71% (p=0.026) </a:t>
            </a:r>
            <a:endParaRPr lang="en-CH" sz="1400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D23344E-7B85-B3B9-FC44-19F906FC4C86}"/>
              </a:ext>
            </a:extLst>
          </p:cNvPr>
          <p:cNvSpPr txBox="1"/>
          <p:nvPr/>
        </p:nvSpPr>
        <p:spPr>
          <a:xfrm>
            <a:off x="10469718" y="6357775"/>
            <a:ext cx="14766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1400" b="1" dirty="0">
                <a:latin typeface="Arial" panose="020B0604020202020204" pitchFamily="34" charset="0"/>
                <a:cs typeface="Arial" panose="020B0604020202020204" pitchFamily="34" charset="0"/>
              </a:rPr>
              <a:t>Suppl. Figure 2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A1F587F-5C0F-C8DB-419B-977EBA4D8A9D}"/>
              </a:ext>
            </a:extLst>
          </p:cNvPr>
          <p:cNvSpPr txBox="1"/>
          <p:nvPr/>
        </p:nvSpPr>
        <p:spPr>
          <a:xfrm>
            <a:off x="435698" y="4771259"/>
            <a:ext cx="11445951" cy="61209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. Figure 2:</a:t>
            </a:r>
            <a:r>
              <a:rPr lang="en-US" sz="12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Kaplan-Meier curves illustrating OS and PFS for the entire cohort of relapsed from initial CSI (cohort A) vs de novo metastatic patients (cohort B).</a:t>
            </a:r>
            <a:r>
              <a:rPr lang="en-US" sz="12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(A)</a:t>
            </a: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2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5-year OS was 94% vs 85% (p =0.0044) and (B) 5-year PFS, 86% vs 71% (p=0.0026) for cohort A vs B, respectively.</a:t>
            </a:r>
            <a:endParaRPr lang="en-CH" sz="12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6271595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 descr="Graphical user interface, chart&#10;&#10;Description automatically generated">
            <a:extLst>
              <a:ext uri="{FF2B5EF4-FFF2-40B4-BE49-F238E27FC236}">
                <a16:creationId xmlns:a16="http://schemas.microsoft.com/office/drawing/2014/main" id="{9342DAB1-9413-4D94-A424-D78760F35ED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84030" y="3429000"/>
            <a:ext cx="4452000" cy="3240000"/>
          </a:xfrm>
          <a:prstGeom prst="rect">
            <a:avLst/>
          </a:prstGeom>
        </p:spPr>
      </p:pic>
      <p:pic>
        <p:nvPicPr>
          <p:cNvPr id="7" name="Picture 6" descr="Graphical user interface&#10;&#10;Description automatically generated">
            <a:extLst>
              <a:ext uri="{FF2B5EF4-FFF2-40B4-BE49-F238E27FC236}">
                <a16:creationId xmlns:a16="http://schemas.microsoft.com/office/drawing/2014/main" id="{4088F0CF-5150-7EA0-D4EE-9CFBAC996E0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84030" y="112185"/>
            <a:ext cx="4452000" cy="3240000"/>
          </a:xfrm>
          <a:prstGeom prst="rect">
            <a:avLst/>
          </a:prstGeom>
        </p:spPr>
      </p:pic>
      <p:pic>
        <p:nvPicPr>
          <p:cNvPr id="5" name="Picture 4" descr="Chart&#10;&#10;Description automatically generated">
            <a:extLst>
              <a:ext uri="{FF2B5EF4-FFF2-40B4-BE49-F238E27FC236}">
                <a16:creationId xmlns:a16="http://schemas.microsoft.com/office/drawing/2014/main" id="{1244FF8E-5ED7-16E2-ACE9-19B1625B14E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9502" y="3409667"/>
            <a:ext cx="4452000" cy="3240000"/>
          </a:xfrm>
          <a:prstGeom prst="rect">
            <a:avLst/>
          </a:prstGeom>
        </p:spPr>
      </p:pic>
      <p:pic>
        <p:nvPicPr>
          <p:cNvPr id="3" name="Picture 2" descr="Graphical user interface&#10;&#10;Description automatically generated">
            <a:extLst>
              <a:ext uri="{FF2B5EF4-FFF2-40B4-BE49-F238E27FC236}">
                <a16:creationId xmlns:a16="http://schemas.microsoft.com/office/drawing/2014/main" id="{A7767DA5-F987-4A2C-F966-F4FC168D2F8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9502" y="70136"/>
            <a:ext cx="4452000" cy="324000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E66EE4BC-40A0-EC18-43D9-7866EE30C1F4}"/>
              </a:ext>
            </a:extLst>
          </p:cNvPr>
          <p:cNvSpPr txBox="1"/>
          <p:nvPr/>
        </p:nvSpPr>
        <p:spPr>
          <a:xfrm>
            <a:off x="10715314" y="6438038"/>
            <a:ext cx="14766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1400" b="1" dirty="0">
                <a:latin typeface="Arial" panose="020B0604020202020204" pitchFamily="34" charset="0"/>
                <a:cs typeface="Arial" panose="020B0604020202020204" pitchFamily="34" charset="0"/>
              </a:rPr>
              <a:t>Suppl. Figure 3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37D0A03-A649-F2FA-A771-F6D962563447}"/>
              </a:ext>
            </a:extLst>
          </p:cNvPr>
          <p:cNvSpPr txBox="1"/>
          <p:nvPr/>
        </p:nvSpPr>
        <p:spPr>
          <a:xfrm>
            <a:off x="-3488" y="19333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CB1B8C6-0C10-37F6-81F2-58E596B9C57E}"/>
              </a:ext>
            </a:extLst>
          </p:cNvPr>
          <p:cNvSpPr txBox="1"/>
          <p:nvPr/>
        </p:nvSpPr>
        <p:spPr>
          <a:xfrm>
            <a:off x="4786373" y="19333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FB77535-814C-33F4-8AC4-588485B110F5}"/>
              </a:ext>
            </a:extLst>
          </p:cNvPr>
          <p:cNvSpPr txBox="1"/>
          <p:nvPr/>
        </p:nvSpPr>
        <p:spPr>
          <a:xfrm>
            <a:off x="-40205" y="3435982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2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2B5263F-A937-0015-7B03-94D6C3DA9325}"/>
              </a:ext>
            </a:extLst>
          </p:cNvPr>
          <p:cNvSpPr txBox="1"/>
          <p:nvPr/>
        </p:nvSpPr>
        <p:spPr>
          <a:xfrm>
            <a:off x="4786373" y="3435982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2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E345EB79-895C-EECE-3C4D-405FCD4B8C64}"/>
              </a:ext>
            </a:extLst>
          </p:cNvPr>
          <p:cNvSpPr txBox="1"/>
          <p:nvPr/>
        </p:nvSpPr>
        <p:spPr>
          <a:xfrm>
            <a:off x="2342126" y="1631745"/>
            <a:ext cx="28868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5-yr OS: 100% vs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</a:rPr>
              <a:t>94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% (p=0.111)</a:t>
            </a:r>
            <a:endParaRPr lang="en-CH" sz="1200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C80D7512-726C-1B64-BC50-733F6AD8C095}"/>
              </a:ext>
            </a:extLst>
          </p:cNvPr>
          <p:cNvSpPr txBox="1"/>
          <p:nvPr/>
        </p:nvSpPr>
        <p:spPr>
          <a:xfrm>
            <a:off x="7254787" y="1654605"/>
            <a:ext cx="28868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5-yr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</a:rPr>
              <a:t>O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: 87% vs 81% (p=0.388) </a:t>
            </a:r>
            <a:endParaRPr lang="en-CH" sz="1200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EC86C3F1-BEB0-0C23-206B-CC5CF390DD2D}"/>
              </a:ext>
            </a:extLst>
          </p:cNvPr>
          <p:cNvSpPr txBox="1"/>
          <p:nvPr/>
        </p:nvSpPr>
        <p:spPr>
          <a:xfrm>
            <a:off x="2329934" y="4962044"/>
            <a:ext cx="28868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5-yr PFS: 92% vs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</a:rPr>
              <a:t>77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% (p=0.047)</a:t>
            </a:r>
            <a:endParaRPr lang="en-CH" sz="1200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7FAB4404-B8D4-E155-C8F5-21753050E3C1}"/>
              </a:ext>
            </a:extLst>
          </p:cNvPr>
          <p:cNvSpPr txBox="1"/>
          <p:nvPr/>
        </p:nvSpPr>
        <p:spPr>
          <a:xfrm>
            <a:off x="7169443" y="4973474"/>
            <a:ext cx="28868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5-yr PFS: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</a:rPr>
              <a:t>78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% vs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</a:rPr>
              <a:t>68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% (p=0.383) </a:t>
            </a:r>
            <a:endParaRPr lang="en-CH" sz="1200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2733907-A58F-BE8A-CEF2-2114161B3A77}"/>
              </a:ext>
            </a:extLst>
          </p:cNvPr>
          <p:cNvSpPr txBox="1"/>
          <p:nvPr/>
        </p:nvSpPr>
        <p:spPr>
          <a:xfrm>
            <a:off x="9862066" y="3512356"/>
            <a:ext cx="2212848" cy="28280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. Figure 3:</a:t>
            </a:r>
            <a:r>
              <a:rPr lang="en-US" sz="12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Kaplan-Meier curves illustrating OS and PFS in GCC patients relapsed from initial CSI (cohort A) vs de novo metastatic patients (cohort B) stratified by histology.</a:t>
            </a:r>
            <a:r>
              <a:rPr lang="en-US" sz="12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(A and C) Seminoma patients; (B and D) Non-seminoma patients.</a:t>
            </a:r>
            <a:endParaRPr lang="en-CH" sz="12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0945126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Graphical user interface&#10;&#10;Description automatically generated">
            <a:extLst>
              <a:ext uri="{FF2B5EF4-FFF2-40B4-BE49-F238E27FC236}">
                <a16:creationId xmlns:a16="http://schemas.microsoft.com/office/drawing/2014/main" id="{A1C5621A-6347-6DAE-6252-A5A7BFFE47C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4662" y="3505815"/>
            <a:ext cx="4452000" cy="3240000"/>
          </a:xfrm>
          <a:prstGeom prst="rect">
            <a:avLst/>
          </a:prstGeom>
        </p:spPr>
      </p:pic>
      <p:pic>
        <p:nvPicPr>
          <p:cNvPr id="32" name="Picture 31" descr="Chart&#10;&#10;Description automatically generated">
            <a:extLst>
              <a:ext uri="{FF2B5EF4-FFF2-40B4-BE49-F238E27FC236}">
                <a16:creationId xmlns:a16="http://schemas.microsoft.com/office/drawing/2014/main" id="{0D47AF87-73B2-0268-32D1-81FD2AD3C38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51769" y="171464"/>
            <a:ext cx="4452000" cy="3240000"/>
          </a:xfrm>
          <a:prstGeom prst="rect">
            <a:avLst/>
          </a:prstGeom>
        </p:spPr>
      </p:pic>
      <p:pic>
        <p:nvPicPr>
          <p:cNvPr id="34" name="Picture 33" descr="Graphical user interface, chart&#10;&#10;Description automatically generated">
            <a:extLst>
              <a:ext uri="{FF2B5EF4-FFF2-40B4-BE49-F238E27FC236}">
                <a16:creationId xmlns:a16="http://schemas.microsoft.com/office/drawing/2014/main" id="{74EC4CC1-45ED-D8B3-4CDC-3C29952F75D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4662" y="171464"/>
            <a:ext cx="4452000" cy="32400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8FCF10F1-0048-AF82-3A08-C0579E6A0E3A}"/>
              </a:ext>
            </a:extLst>
          </p:cNvPr>
          <p:cNvSpPr txBox="1"/>
          <p:nvPr/>
        </p:nvSpPr>
        <p:spPr>
          <a:xfrm>
            <a:off x="10715314" y="6438038"/>
            <a:ext cx="14766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1400" b="1" dirty="0">
                <a:latin typeface="Arial" panose="020B0604020202020204" pitchFamily="34" charset="0"/>
                <a:cs typeface="Arial" panose="020B0604020202020204" pitchFamily="34" charset="0"/>
              </a:rPr>
              <a:t>Suppl. Figure 4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1FF70FB-1E3A-AB47-13B4-2DE7CB2D9DF8}"/>
              </a:ext>
            </a:extLst>
          </p:cNvPr>
          <p:cNvSpPr txBox="1"/>
          <p:nvPr/>
        </p:nvSpPr>
        <p:spPr>
          <a:xfrm>
            <a:off x="94048" y="19333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9DC1E06-53DA-7B8C-CAAA-2A0CC5AF0732}"/>
              </a:ext>
            </a:extLst>
          </p:cNvPr>
          <p:cNvSpPr txBox="1"/>
          <p:nvPr/>
        </p:nvSpPr>
        <p:spPr>
          <a:xfrm>
            <a:off x="5188709" y="19333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9BBE8DD4-56C1-1A88-65BA-7F5E1BE811F3}"/>
              </a:ext>
            </a:extLst>
          </p:cNvPr>
          <p:cNvSpPr txBox="1"/>
          <p:nvPr/>
        </p:nvSpPr>
        <p:spPr>
          <a:xfrm>
            <a:off x="57331" y="3843947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2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4427D38-6FD7-A04B-F594-FDBB2B171607}"/>
              </a:ext>
            </a:extLst>
          </p:cNvPr>
          <p:cNvSpPr txBox="1"/>
          <p:nvPr/>
        </p:nvSpPr>
        <p:spPr>
          <a:xfrm>
            <a:off x="2409182" y="1707358"/>
            <a:ext cx="28868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5-yr OS: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</a:rPr>
              <a:t>92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% vs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</a:rPr>
              <a:t>91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% (p=0.7)</a:t>
            </a:r>
            <a:endParaRPr lang="en-CH" sz="1200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05995B7B-FDE7-512C-CF2B-3D82A66D24A8}"/>
              </a:ext>
            </a:extLst>
          </p:cNvPr>
          <p:cNvSpPr txBox="1"/>
          <p:nvPr/>
        </p:nvSpPr>
        <p:spPr>
          <a:xfrm>
            <a:off x="7801141" y="1707358"/>
            <a:ext cx="28868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5-yr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</a:rPr>
              <a:t>O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: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</a:rPr>
              <a:t>80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% vs 80% (p=0.93) </a:t>
            </a:r>
            <a:endParaRPr lang="en-CH" sz="1200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82B4D34C-341C-F2C3-78F6-015C6700C79C}"/>
              </a:ext>
            </a:extLst>
          </p:cNvPr>
          <p:cNvSpPr txBox="1"/>
          <p:nvPr/>
        </p:nvSpPr>
        <p:spPr>
          <a:xfrm>
            <a:off x="2409182" y="5054863"/>
            <a:ext cx="28868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5-yr OS: 100% vs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</a:rPr>
              <a:t>95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% (p=0.151)</a:t>
            </a:r>
            <a:endParaRPr lang="en-CH" sz="1200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8DF31D1-8B46-0E1C-8448-F224E6204EB9}"/>
              </a:ext>
            </a:extLst>
          </p:cNvPr>
          <p:cNvSpPr txBox="1"/>
          <p:nvPr/>
        </p:nvSpPr>
        <p:spPr>
          <a:xfrm>
            <a:off x="5296031" y="5054863"/>
            <a:ext cx="6108192" cy="116608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. Figure 4:</a:t>
            </a:r>
            <a:r>
              <a:rPr lang="en-US" sz="12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Kaplan-Meier curves for OS in cohort A vs. cohort B stratified by histology and IGCCCG prognostic group.</a:t>
            </a:r>
            <a:r>
              <a:rPr lang="en-US" sz="12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(A) Non-seminoma, good prognostic group, (B) Non-seminoma, intermediate prognostic group, (C) Seminoma, good prognostic group.</a:t>
            </a:r>
            <a:endParaRPr lang="en-CH" sz="12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8125964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Chart&#10;&#10;Description automatically generated">
            <a:extLst>
              <a:ext uri="{FF2B5EF4-FFF2-40B4-BE49-F238E27FC236}">
                <a16:creationId xmlns:a16="http://schemas.microsoft.com/office/drawing/2014/main" id="{8483E89A-E26A-E734-1269-21CF77944C1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4489" y="163326"/>
            <a:ext cx="4452000" cy="3240000"/>
          </a:xfrm>
          <a:prstGeom prst="rect">
            <a:avLst/>
          </a:prstGeom>
        </p:spPr>
      </p:pic>
      <p:pic>
        <p:nvPicPr>
          <p:cNvPr id="4" name="Picture 3" descr="Chart&#10;&#10;Description automatically generated">
            <a:extLst>
              <a:ext uri="{FF2B5EF4-FFF2-40B4-BE49-F238E27FC236}">
                <a16:creationId xmlns:a16="http://schemas.microsoft.com/office/drawing/2014/main" id="{61FB3EEC-8DB8-3DC0-B32B-F77CC12C1E4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4489" y="3559078"/>
            <a:ext cx="4452000" cy="3240000"/>
          </a:xfrm>
          <a:prstGeom prst="rect">
            <a:avLst/>
          </a:prstGeom>
        </p:spPr>
      </p:pic>
      <p:pic>
        <p:nvPicPr>
          <p:cNvPr id="10" name="Picture 9" descr="Graphical user interface, chart&#10;&#10;Description automatically generated with medium confidence">
            <a:extLst>
              <a:ext uri="{FF2B5EF4-FFF2-40B4-BE49-F238E27FC236}">
                <a16:creationId xmlns:a16="http://schemas.microsoft.com/office/drawing/2014/main" id="{7C6A7B8A-5158-A5E8-C061-17E530C9454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21263" y="163326"/>
            <a:ext cx="4452000" cy="32400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8FCF10F1-0048-AF82-3A08-C0579E6A0E3A}"/>
              </a:ext>
            </a:extLst>
          </p:cNvPr>
          <p:cNvSpPr txBox="1"/>
          <p:nvPr/>
        </p:nvSpPr>
        <p:spPr>
          <a:xfrm>
            <a:off x="10715314" y="6438038"/>
            <a:ext cx="14766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1400" b="1" dirty="0">
                <a:latin typeface="Arial" panose="020B0604020202020204" pitchFamily="34" charset="0"/>
                <a:cs typeface="Arial" panose="020B0604020202020204" pitchFamily="34" charset="0"/>
              </a:rPr>
              <a:t>Suppl. Figure 5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05995B7B-FDE7-512C-CF2B-3D82A66D24A8}"/>
              </a:ext>
            </a:extLst>
          </p:cNvPr>
          <p:cNvSpPr txBox="1"/>
          <p:nvPr/>
        </p:nvSpPr>
        <p:spPr>
          <a:xfrm>
            <a:off x="7773709" y="1656096"/>
            <a:ext cx="28868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5-yr PFS: 74% vs 77% (p=0.87) </a:t>
            </a:r>
            <a:endParaRPr lang="en-CH" sz="1200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DCAB95C-A1FA-9FB8-52B9-DC42FE9AB4BA}"/>
              </a:ext>
            </a:extLst>
          </p:cNvPr>
          <p:cNvSpPr txBox="1"/>
          <p:nvPr/>
        </p:nvSpPr>
        <p:spPr>
          <a:xfrm>
            <a:off x="94048" y="19333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E525923B-7D48-AA86-C975-19854BB7B9E6}"/>
              </a:ext>
            </a:extLst>
          </p:cNvPr>
          <p:cNvSpPr txBox="1"/>
          <p:nvPr/>
        </p:nvSpPr>
        <p:spPr>
          <a:xfrm>
            <a:off x="5188709" y="19333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F04A3A9-6CD9-87C0-C5A1-6881461CF05E}"/>
              </a:ext>
            </a:extLst>
          </p:cNvPr>
          <p:cNvSpPr txBox="1"/>
          <p:nvPr/>
        </p:nvSpPr>
        <p:spPr>
          <a:xfrm>
            <a:off x="57331" y="3843947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2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B819BF5D-5F0A-34CF-7A82-F53BC84A571D}"/>
              </a:ext>
            </a:extLst>
          </p:cNvPr>
          <p:cNvSpPr txBox="1"/>
          <p:nvPr/>
        </p:nvSpPr>
        <p:spPr>
          <a:xfrm>
            <a:off x="2598920" y="1656096"/>
            <a:ext cx="28868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5-yr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</a:rPr>
              <a:t>PFS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: 82% vs 69% (p=0.57)</a:t>
            </a:r>
            <a:endParaRPr lang="en-CH" sz="1200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44491DE2-5B85-FA83-5ABF-D44BE5F491D5}"/>
              </a:ext>
            </a:extLst>
          </p:cNvPr>
          <p:cNvSpPr txBox="1"/>
          <p:nvPr/>
        </p:nvSpPr>
        <p:spPr>
          <a:xfrm>
            <a:off x="2586728" y="5082036"/>
            <a:ext cx="28868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5-yr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</a:rPr>
              <a:t>PFS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: 92% vs 77% (p=0.45)</a:t>
            </a:r>
            <a:endParaRPr lang="en-CH" sz="12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E40BC7B-F597-D84C-0993-A88951033F36}"/>
              </a:ext>
            </a:extLst>
          </p:cNvPr>
          <p:cNvSpPr txBox="1"/>
          <p:nvPr/>
        </p:nvSpPr>
        <p:spPr>
          <a:xfrm>
            <a:off x="5485769" y="5082036"/>
            <a:ext cx="6108192" cy="116608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. Figure 5:</a:t>
            </a:r>
            <a:r>
              <a:rPr lang="en-US" sz="12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200" b="1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Kaplan-Meier curves for PFS in cohort A vs. cohort B stratified by histology and IGCCCG prognostic group.</a:t>
            </a:r>
            <a:r>
              <a:rPr lang="en-US" sz="12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it-CH" sz="1200" dirty="0">
                <a:solidFill>
                  <a:srgbClr val="212121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A) Non-seminoma, good prognostic group, (B) Non-seminoma, intermediate prognostic group, (C) Seminoma, good prognostic group.</a:t>
            </a:r>
            <a:endParaRPr lang="en-CH" sz="12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28038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251</TotalTime>
  <Words>524</Words>
  <Application>Microsoft Macintosh PowerPoint</Application>
  <PresentationFormat>Widescreen</PresentationFormat>
  <Paragraphs>35</Paragraphs>
  <Slides>5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peicher Philip</dc:creator>
  <cp:lastModifiedBy>Dilara Akhoundova</cp:lastModifiedBy>
  <cp:revision>109</cp:revision>
  <dcterms:created xsi:type="dcterms:W3CDTF">2023-02-16T22:15:16Z</dcterms:created>
  <dcterms:modified xsi:type="dcterms:W3CDTF">2023-09-07T07:03:59Z</dcterms:modified>
</cp:coreProperties>
</file>